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592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11BD1C3-6CA8-3899-BAE6-9E733137ECD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B8715C7-11F0-F44F-5602-CAA32B6E33B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D4C598D-A944-2804-9B91-B0FBF14D50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0FB3-8410-4868-9850-CD27F471F128}" type="datetimeFigureOut">
              <a:rPr kumimoji="1" lang="ja-JP" altLang="en-US" smtClean="0"/>
              <a:t>2023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84E1BCF-2379-2B10-DEB3-5B11DAD388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AA033E6-925A-C06B-826E-1E6C91A82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98E03-0BB2-43A4-B190-FA88D4697F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71047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9BA834C-6BA2-00F5-09C1-239716D73B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B083205-5FFA-0D7F-EF26-9F40FCF83A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51C0819-5E3A-CCDD-7ED8-3B6CD4994E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0FB3-8410-4868-9850-CD27F471F128}" type="datetimeFigureOut">
              <a:rPr kumimoji="1" lang="ja-JP" altLang="en-US" smtClean="0"/>
              <a:t>2023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C1656D-D8BC-9A39-FEAD-ADB65306E0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FBAF4F8-53D9-BD6A-DF7E-7D6EC39503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98E03-0BB2-43A4-B190-FA88D4697F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4121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F9C31E4-6C5A-73B3-0E41-6137D635F3C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BC37815-743B-DEC4-4E0E-AEE15E4307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48FED4A-8EC2-84E9-3049-276B63E8FC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0FB3-8410-4868-9850-CD27F471F128}" type="datetimeFigureOut">
              <a:rPr kumimoji="1" lang="ja-JP" altLang="en-US" smtClean="0"/>
              <a:t>2023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D2C508A-D957-7006-1037-719D7370AC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30B8D43-92D9-2815-0A6F-9AD20A85AA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98E03-0BB2-43A4-B190-FA88D4697F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276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79B095C-40F0-3183-9808-EFC4AF873E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E0F374F-8C0C-61F5-A9EB-9928F7C54B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AF74AB5-3414-C37D-FC48-CC31F6F755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0FB3-8410-4868-9850-CD27F471F128}" type="datetimeFigureOut">
              <a:rPr kumimoji="1" lang="ja-JP" altLang="en-US" smtClean="0"/>
              <a:t>2023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3481934-3653-A961-76F5-1F39E6B87B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9C45B47-0ADC-69EE-E8C4-1CAD1BA6B4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98E03-0BB2-43A4-B190-FA88D4697F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70874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E9DA38D-376E-4B04-6E5C-1D51BE7F27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EB125B0-593D-6B48-9250-F9A65C8F6C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885E96-ECAF-8785-0848-2B1FACA97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0FB3-8410-4868-9850-CD27F471F128}" type="datetimeFigureOut">
              <a:rPr kumimoji="1" lang="ja-JP" altLang="en-US" smtClean="0"/>
              <a:t>2023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456BE3E-8078-F609-9311-8F3A74FDD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EDE206D-120D-9242-643A-79C274636D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98E03-0BB2-43A4-B190-FA88D4697F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731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3C5C1CB-B98A-B64C-CFC2-D6777944CD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2B1E00A-64F2-DDD6-6588-796B9585B59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0EB4787-E7A3-B206-1AC3-2833A8D3EA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3608B75-0F8A-2D1D-2871-485DAA26A7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0FB3-8410-4868-9850-CD27F471F128}" type="datetimeFigureOut">
              <a:rPr kumimoji="1" lang="ja-JP" altLang="en-US" smtClean="0"/>
              <a:t>2023/11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2B1DFBC-44C4-0AE3-34AA-121439F8D5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066053D-5E5F-0592-9BDD-C0E2D116ED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98E03-0BB2-43A4-B190-FA88D4697F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36542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20B875-C391-A432-255F-1853EB0C1B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A42B3B2-7ADD-DE3C-B5C2-0D80939A1D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AE4D50B-917F-A8F7-EA45-A59A104F09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E95E360-740E-2E5E-88A6-58BFAC57B5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F4C3279-1A75-6976-6056-20B83A6724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B4FE0EE-8DA0-9FA2-DD57-B1561AB797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0FB3-8410-4868-9850-CD27F471F128}" type="datetimeFigureOut">
              <a:rPr kumimoji="1" lang="ja-JP" altLang="en-US" smtClean="0"/>
              <a:t>2023/11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9C5CB30-BA22-9A51-18B5-1559FCF1ED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63D8188-6F19-8BB4-B5AA-202CB33D93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98E03-0BB2-43A4-B190-FA88D4697F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449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127E07-02F7-218A-F599-6262FA09E8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65E5147-3D6B-4DA9-EE40-397DC933EB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0FB3-8410-4868-9850-CD27F471F128}" type="datetimeFigureOut">
              <a:rPr kumimoji="1" lang="ja-JP" altLang="en-US" smtClean="0"/>
              <a:t>2023/11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DE299B6-DD81-7EEE-68E9-7A4472C95A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EC35988-9897-1A8F-6FDD-42CDEEE1D6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98E03-0BB2-43A4-B190-FA88D4697F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8190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9487D1C-2225-8471-EFD4-3E3430D48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0FB3-8410-4868-9850-CD27F471F128}" type="datetimeFigureOut">
              <a:rPr kumimoji="1" lang="ja-JP" altLang="en-US" smtClean="0"/>
              <a:t>2023/11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5DFFCAC-DE38-D9F6-E3FD-43D2937A82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1DC7D0C-E0A3-3FCF-423E-5DC4321C0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98E03-0BB2-43A4-B190-FA88D4697F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3986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B8446A-3835-89EF-57D4-69D1FE195D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641A601-B8B8-C0DC-1307-1EA8DFB0E2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6C291FC-61F9-3A03-37AE-61C9719538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1AB14D9-8887-80FD-FB58-89E2874AC2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0FB3-8410-4868-9850-CD27F471F128}" type="datetimeFigureOut">
              <a:rPr kumimoji="1" lang="ja-JP" altLang="en-US" smtClean="0"/>
              <a:t>2023/11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506B6CC-F0A0-1967-F780-21DB767BD8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75B837F-6564-3DB4-B80B-F368184ECD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98E03-0BB2-43A4-B190-FA88D4697F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6693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8A0F2F7-471A-51CA-E680-AE3E7E5BE6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0739147-2740-851C-CEE3-802FF8F485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58ADBFA-C7B5-D96E-1ED8-C4841F2B80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C11AF9B-028F-10AE-7F13-E5D0B0A704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0FB3-8410-4868-9850-CD27F471F128}" type="datetimeFigureOut">
              <a:rPr kumimoji="1" lang="ja-JP" altLang="en-US" smtClean="0"/>
              <a:t>2023/11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83C3669-3FED-C29A-7F79-D73E97A97A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90A202A-B58E-63AE-CC36-050D1212B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098E03-0BB2-43A4-B190-FA88D4697F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75874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277ABDD-6532-0E68-1A29-CBAA1CC518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57DAE3C-E0E3-6BDA-FA94-BC483F17A0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D9BB4A9-39B9-DFFC-DEA5-8D86ACC9BC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A30FB3-8410-4868-9850-CD27F471F128}" type="datetimeFigureOut">
              <a:rPr kumimoji="1" lang="ja-JP" altLang="en-US" smtClean="0"/>
              <a:t>2023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34A7537-B386-729F-5BA4-5B2A39FB935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E010484-1CDE-BB81-DA8F-FBE5F5F5D0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098E03-0BB2-43A4-B190-FA88D4697F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6905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81BE967C-6BB2-434E-61F2-28378D6BE64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6326" y="1429633"/>
            <a:ext cx="4359897" cy="3237224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05104C5-0A14-2675-4AA1-4BC93AF7A0FD}"/>
              </a:ext>
            </a:extLst>
          </p:cNvPr>
          <p:cNvSpPr txBox="1"/>
          <p:nvPr/>
        </p:nvSpPr>
        <p:spPr>
          <a:xfrm>
            <a:off x="3306452" y="4864231"/>
            <a:ext cx="528136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Century" panose="02040604050505020304" pitchFamily="18" charset="0"/>
              </a:rPr>
              <a:t>FIGURE S1 Histopathological examination of the rectal mucosa at the site of the tree-like appearance (CD31 stain, magnification: ×</a:t>
            </a:r>
            <a:r>
              <a:rPr kumimoji="1" lang="en-US" altLang="ja-JP" sz="1600">
                <a:latin typeface="Century" panose="02040604050505020304" pitchFamily="18" charset="0"/>
              </a:rPr>
              <a:t>200).</a:t>
            </a:r>
            <a:endParaRPr kumimoji="1" lang="ja-JP" altLang="en-US" sz="1600" dirty="0">
              <a:latin typeface="Century" panose="020406040505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47642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24</Words>
  <Application>Microsoft Office PowerPoint</Application>
  <PresentationFormat>ワイド画面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entury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雄紀 廣瀬</dc:creator>
  <cp:lastModifiedBy>雄紀 廣瀬</cp:lastModifiedBy>
  <cp:revision>5</cp:revision>
  <dcterms:created xsi:type="dcterms:W3CDTF">2023-11-05T13:54:59Z</dcterms:created>
  <dcterms:modified xsi:type="dcterms:W3CDTF">2023-11-06T04:04:24Z</dcterms:modified>
</cp:coreProperties>
</file>